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4859338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8" userDrawn="1">
          <p15:clr>
            <a:srgbClr val="A4A3A4"/>
          </p15:clr>
        </p15:guide>
        <p15:guide id="2" pos="153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9" d="100"/>
          <a:sy n="69" d="100"/>
        </p:scale>
        <p:origin x="2779" y="62"/>
      </p:cViewPr>
      <p:guideLst>
        <p:guide orient="horz" pos="2528"/>
        <p:guide pos="15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64451" y="1325531"/>
            <a:ext cx="4130437" cy="2819800"/>
          </a:xfrm>
        </p:spPr>
        <p:txBody>
          <a:bodyPr anchor="b"/>
          <a:lstStyle>
            <a:lvl1pPr algn="ctr">
              <a:defRPr sz="318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07417" y="4254073"/>
            <a:ext cx="3644504" cy="1955486"/>
          </a:xfrm>
        </p:spPr>
        <p:txBody>
          <a:bodyPr/>
          <a:lstStyle>
            <a:lvl1pPr marL="0" indent="0" algn="ctr">
              <a:buNone/>
              <a:defRPr sz="1275"/>
            </a:lvl1pPr>
            <a:lvl2pPr marL="242956" indent="0" algn="ctr">
              <a:buNone/>
              <a:defRPr sz="1063"/>
            </a:lvl2pPr>
            <a:lvl3pPr marL="485912" indent="0" algn="ctr">
              <a:buNone/>
              <a:defRPr sz="957"/>
            </a:lvl3pPr>
            <a:lvl4pPr marL="728868" indent="0" algn="ctr">
              <a:buNone/>
              <a:defRPr sz="850"/>
            </a:lvl4pPr>
            <a:lvl5pPr marL="971824" indent="0" algn="ctr">
              <a:buNone/>
              <a:defRPr sz="850"/>
            </a:lvl5pPr>
            <a:lvl6pPr marL="1214780" indent="0" algn="ctr">
              <a:buNone/>
              <a:defRPr sz="850"/>
            </a:lvl6pPr>
            <a:lvl7pPr marL="1457736" indent="0" algn="ctr">
              <a:buNone/>
              <a:defRPr sz="850"/>
            </a:lvl7pPr>
            <a:lvl8pPr marL="1700693" indent="0" algn="ctr">
              <a:buNone/>
              <a:defRPr sz="850"/>
            </a:lvl8pPr>
            <a:lvl9pPr marL="1943649" indent="0" algn="ctr">
              <a:buNone/>
              <a:defRPr sz="85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6372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0545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77464" y="431220"/>
            <a:ext cx="1047795" cy="686388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4080" y="431220"/>
            <a:ext cx="3082643" cy="686388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228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7860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1549" y="2019234"/>
            <a:ext cx="4191179" cy="3369135"/>
          </a:xfrm>
        </p:spPr>
        <p:txBody>
          <a:bodyPr anchor="b"/>
          <a:lstStyle>
            <a:lvl1pPr>
              <a:defRPr sz="318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1549" y="5420242"/>
            <a:ext cx="4191179" cy="1771749"/>
          </a:xfrm>
        </p:spPr>
        <p:txBody>
          <a:bodyPr/>
          <a:lstStyle>
            <a:lvl1pPr marL="0" indent="0">
              <a:buNone/>
              <a:defRPr sz="1275">
                <a:solidFill>
                  <a:schemeClr val="tx1"/>
                </a:solidFill>
              </a:defRPr>
            </a:lvl1pPr>
            <a:lvl2pPr marL="242956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2pPr>
            <a:lvl3pPr marL="485912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3pPr>
            <a:lvl4pPr marL="728868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4pPr>
            <a:lvl5pPr marL="971824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5pPr>
            <a:lvl6pPr marL="1214780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6pPr>
            <a:lvl7pPr marL="1457736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7pPr>
            <a:lvl8pPr marL="170069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8pPr>
            <a:lvl9pPr marL="1943649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3902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4079" y="2156097"/>
            <a:ext cx="2065219" cy="513901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60040" y="2156097"/>
            <a:ext cx="2065219" cy="5139011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9169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431221"/>
            <a:ext cx="4191179" cy="1565514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4713" y="1985485"/>
            <a:ext cx="2055727" cy="973055"/>
          </a:xfrm>
        </p:spPr>
        <p:txBody>
          <a:bodyPr anchor="b"/>
          <a:lstStyle>
            <a:lvl1pPr marL="0" indent="0">
              <a:buNone/>
              <a:defRPr sz="1275" b="1"/>
            </a:lvl1pPr>
            <a:lvl2pPr marL="242956" indent="0">
              <a:buNone/>
              <a:defRPr sz="1063" b="1"/>
            </a:lvl2pPr>
            <a:lvl3pPr marL="485912" indent="0">
              <a:buNone/>
              <a:defRPr sz="957" b="1"/>
            </a:lvl3pPr>
            <a:lvl4pPr marL="728868" indent="0">
              <a:buNone/>
              <a:defRPr sz="850" b="1"/>
            </a:lvl4pPr>
            <a:lvl5pPr marL="971824" indent="0">
              <a:buNone/>
              <a:defRPr sz="850" b="1"/>
            </a:lvl5pPr>
            <a:lvl6pPr marL="1214780" indent="0">
              <a:buNone/>
              <a:defRPr sz="850" b="1"/>
            </a:lvl6pPr>
            <a:lvl7pPr marL="1457736" indent="0">
              <a:buNone/>
              <a:defRPr sz="850" b="1"/>
            </a:lvl7pPr>
            <a:lvl8pPr marL="1700693" indent="0">
              <a:buNone/>
              <a:defRPr sz="850" b="1"/>
            </a:lvl8pPr>
            <a:lvl9pPr marL="1943649" indent="0">
              <a:buNone/>
              <a:defRPr sz="85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4713" y="2958540"/>
            <a:ext cx="2055727" cy="4351567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460040" y="1985485"/>
            <a:ext cx="2065852" cy="973055"/>
          </a:xfrm>
        </p:spPr>
        <p:txBody>
          <a:bodyPr anchor="b"/>
          <a:lstStyle>
            <a:lvl1pPr marL="0" indent="0">
              <a:buNone/>
              <a:defRPr sz="1275" b="1"/>
            </a:lvl1pPr>
            <a:lvl2pPr marL="242956" indent="0">
              <a:buNone/>
              <a:defRPr sz="1063" b="1"/>
            </a:lvl2pPr>
            <a:lvl3pPr marL="485912" indent="0">
              <a:buNone/>
              <a:defRPr sz="957" b="1"/>
            </a:lvl3pPr>
            <a:lvl4pPr marL="728868" indent="0">
              <a:buNone/>
              <a:defRPr sz="850" b="1"/>
            </a:lvl4pPr>
            <a:lvl5pPr marL="971824" indent="0">
              <a:buNone/>
              <a:defRPr sz="850" b="1"/>
            </a:lvl5pPr>
            <a:lvl6pPr marL="1214780" indent="0">
              <a:buNone/>
              <a:defRPr sz="850" b="1"/>
            </a:lvl6pPr>
            <a:lvl7pPr marL="1457736" indent="0">
              <a:buNone/>
              <a:defRPr sz="850" b="1"/>
            </a:lvl7pPr>
            <a:lvl8pPr marL="1700693" indent="0">
              <a:buNone/>
              <a:defRPr sz="850" b="1"/>
            </a:lvl8pPr>
            <a:lvl9pPr marL="1943649" indent="0">
              <a:buNone/>
              <a:defRPr sz="85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60040" y="2958540"/>
            <a:ext cx="2065852" cy="4351567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46533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7979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2151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539962"/>
            <a:ext cx="1567263" cy="1889866"/>
          </a:xfrm>
        </p:spPr>
        <p:txBody>
          <a:bodyPr anchor="b"/>
          <a:lstStyle>
            <a:lvl1pPr>
              <a:defRPr sz="17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65852" y="1166169"/>
            <a:ext cx="2460040" cy="5755841"/>
          </a:xfrm>
        </p:spPr>
        <p:txBody>
          <a:bodyPr/>
          <a:lstStyle>
            <a:lvl1pPr>
              <a:defRPr sz="1700"/>
            </a:lvl1pPr>
            <a:lvl2pPr>
              <a:defRPr sz="1488"/>
            </a:lvl2pPr>
            <a:lvl3pPr>
              <a:defRPr sz="1275"/>
            </a:lvl3pPr>
            <a:lvl4pPr>
              <a:defRPr sz="1063"/>
            </a:lvl4pPr>
            <a:lvl5pPr>
              <a:defRPr sz="1063"/>
            </a:lvl5pPr>
            <a:lvl6pPr>
              <a:defRPr sz="1063"/>
            </a:lvl6pPr>
            <a:lvl7pPr>
              <a:defRPr sz="1063"/>
            </a:lvl7pPr>
            <a:lvl8pPr>
              <a:defRPr sz="1063"/>
            </a:lvl8pPr>
            <a:lvl9pPr>
              <a:defRPr sz="106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4712" y="2429828"/>
            <a:ext cx="1567263" cy="4501556"/>
          </a:xfrm>
        </p:spPr>
        <p:txBody>
          <a:bodyPr/>
          <a:lstStyle>
            <a:lvl1pPr marL="0" indent="0">
              <a:buNone/>
              <a:defRPr sz="850"/>
            </a:lvl1pPr>
            <a:lvl2pPr marL="242956" indent="0">
              <a:buNone/>
              <a:defRPr sz="744"/>
            </a:lvl2pPr>
            <a:lvl3pPr marL="485912" indent="0">
              <a:buNone/>
              <a:defRPr sz="638"/>
            </a:lvl3pPr>
            <a:lvl4pPr marL="728868" indent="0">
              <a:buNone/>
              <a:defRPr sz="531"/>
            </a:lvl4pPr>
            <a:lvl5pPr marL="971824" indent="0">
              <a:buNone/>
              <a:defRPr sz="531"/>
            </a:lvl5pPr>
            <a:lvl6pPr marL="1214780" indent="0">
              <a:buNone/>
              <a:defRPr sz="531"/>
            </a:lvl6pPr>
            <a:lvl7pPr marL="1457736" indent="0">
              <a:buNone/>
              <a:defRPr sz="531"/>
            </a:lvl7pPr>
            <a:lvl8pPr marL="1700693" indent="0">
              <a:buNone/>
              <a:defRPr sz="531"/>
            </a:lvl8pPr>
            <a:lvl9pPr marL="1943649" indent="0">
              <a:buNone/>
              <a:defRPr sz="53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9508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539962"/>
            <a:ext cx="1567263" cy="1889866"/>
          </a:xfrm>
        </p:spPr>
        <p:txBody>
          <a:bodyPr anchor="b"/>
          <a:lstStyle>
            <a:lvl1pPr>
              <a:defRPr sz="17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065852" y="1166169"/>
            <a:ext cx="2460040" cy="5755841"/>
          </a:xfrm>
        </p:spPr>
        <p:txBody>
          <a:bodyPr anchor="t"/>
          <a:lstStyle>
            <a:lvl1pPr marL="0" indent="0">
              <a:buNone/>
              <a:defRPr sz="1700"/>
            </a:lvl1pPr>
            <a:lvl2pPr marL="242956" indent="0">
              <a:buNone/>
              <a:defRPr sz="1488"/>
            </a:lvl2pPr>
            <a:lvl3pPr marL="485912" indent="0">
              <a:buNone/>
              <a:defRPr sz="1275"/>
            </a:lvl3pPr>
            <a:lvl4pPr marL="728868" indent="0">
              <a:buNone/>
              <a:defRPr sz="1063"/>
            </a:lvl4pPr>
            <a:lvl5pPr marL="971824" indent="0">
              <a:buNone/>
              <a:defRPr sz="1063"/>
            </a:lvl5pPr>
            <a:lvl6pPr marL="1214780" indent="0">
              <a:buNone/>
              <a:defRPr sz="1063"/>
            </a:lvl6pPr>
            <a:lvl7pPr marL="1457736" indent="0">
              <a:buNone/>
              <a:defRPr sz="1063"/>
            </a:lvl7pPr>
            <a:lvl8pPr marL="1700693" indent="0">
              <a:buNone/>
              <a:defRPr sz="1063"/>
            </a:lvl8pPr>
            <a:lvl9pPr marL="1943649" indent="0">
              <a:buNone/>
              <a:defRPr sz="1063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4712" y="2429828"/>
            <a:ext cx="1567263" cy="4501556"/>
          </a:xfrm>
        </p:spPr>
        <p:txBody>
          <a:bodyPr/>
          <a:lstStyle>
            <a:lvl1pPr marL="0" indent="0">
              <a:buNone/>
              <a:defRPr sz="850"/>
            </a:lvl1pPr>
            <a:lvl2pPr marL="242956" indent="0">
              <a:buNone/>
              <a:defRPr sz="744"/>
            </a:lvl2pPr>
            <a:lvl3pPr marL="485912" indent="0">
              <a:buNone/>
              <a:defRPr sz="638"/>
            </a:lvl3pPr>
            <a:lvl4pPr marL="728868" indent="0">
              <a:buNone/>
              <a:defRPr sz="531"/>
            </a:lvl4pPr>
            <a:lvl5pPr marL="971824" indent="0">
              <a:buNone/>
              <a:defRPr sz="531"/>
            </a:lvl5pPr>
            <a:lvl6pPr marL="1214780" indent="0">
              <a:buNone/>
              <a:defRPr sz="531"/>
            </a:lvl6pPr>
            <a:lvl7pPr marL="1457736" indent="0">
              <a:buNone/>
              <a:defRPr sz="531"/>
            </a:lvl7pPr>
            <a:lvl8pPr marL="1700693" indent="0">
              <a:buNone/>
              <a:defRPr sz="531"/>
            </a:lvl8pPr>
            <a:lvl9pPr marL="1943649" indent="0">
              <a:buNone/>
              <a:defRPr sz="53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6657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34080" y="431221"/>
            <a:ext cx="419117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4080" y="2156097"/>
            <a:ext cx="419117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34080" y="7506969"/>
            <a:ext cx="1093351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5919D-5874-4E9F-868C-0A7F32A1B0DB}" type="datetimeFigureOut">
              <a:rPr lang="zh-TW" altLang="en-US" smtClean="0"/>
              <a:t>2024/2/1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09656" y="7506969"/>
            <a:ext cx="164002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31907" y="7506969"/>
            <a:ext cx="1093351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93A30-89B2-471C-AA9D-33053FB5E30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36535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485912" rtl="0" eaLnBrk="1" latinLnBrk="0" hangingPunct="1">
        <a:lnSpc>
          <a:spcPct val="90000"/>
        </a:lnSpc>
        <a:spcBef>
          <a:spcPct val="0"/>
        </a:spcBef>
        <a:buNone/>
        <a:defRPr sz="23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478" indent="-121478" algn="l" defTabSz="485912" rtl="0" eaLnBrk="1" latinLnBrk="0" hangingPunct="1">
        <a:lnSpc>
          <a:spcPct val="90000"/>
        </a:lnSpc>
        <a:spcBef>
          <a:spcPts val="531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64434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2pPr>
      <a:lvl3pPr marL="607390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50346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4pPr>
      <a:lvl5pPr marL="1093302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5pPr>
      <a:lvl6pPr marL="1336258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6pPr>
      <a:lvl7pPr marL="1579215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7pPr>
      <a:lvl8pPr marL="1822171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8pPr>
      <a:lvl9pPr marL="2065127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1pPr>
      <a:lvl2pPr marL="242956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2pPr>
      <a:lvl3pPr marL="485912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3pPr>
      <a:lvl4pPr marL="728868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4pPr>
      <a:lvl5pPr marL="971824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5pPr>
      <a:lvl6pPr marL="1214780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6pPr>
      <a:lvl7pPr marL="1457736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7pPr>
      <a:lvl8pPr marL="1700693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8pPr>
      <a:lvl9pPr marL="1943649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4434AD9D-D770-4C37-9CB6-92FABFBF47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6"/>
          <a:stretch/>
        </p:blipFill>
        <p:spPr>
          <a:xfrm>
            <a:off x="1" y="1"/>
            <a:ext cx="4859338" cy="7563456"/>
          </a:xfrm>
          <a:prstGeom prst="rect">
            <a:avLst/>
          </a:prstGeom>
        </p:spPr>
      </p:pic>
      <p:sp>
        <p:nvSpPr>
          <p:cNvPr id="7" name="文字方塊 6">
            <a:extLst>
              <a:ext uri="{FF2B5EF4-FFF2-40B4-BE49-F238E27FC236}">
                <a16:creationId xmlns:a16="http://schemas.microsoft.com/office/drawing/2014/main" id="{FB652D7A-27F4-44AC-A001-37D61061D0BB}"/>
              </a:ext>
            </a:extLst>
          </p:cNvPr>
          <p:cNvSpPr txBox="1"/>
          <p:nvPr/>
        </p:nvSpPr>
        <p:spPr>
          <a:xfrm>
            <a:off x="0" y="7618779"/>
            <a:ext cx="485933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TW" sz="1200" b="1" kern="0" dirty="0">
                <a:solidFill>
                  <a:srgbClr val="000000"/>
                </a:solidFill>
                <a:ea typeface="新細明體" panose="02020500000000000000" pitchFamily="18" charset="-120"/>
              </a:rPr>
              <a:t>Figure Additional file 8.</a:t>
            </a:r>
            <a:r>
              <a:rPr lang="zh-TW" altLang="en-US" sz="1200" kern="0" dirty="0">
                <a:solidFill>
                  <a:srgbClr val="000000"/>
                </a:solidFill>
                <a:ea typeface="新細明體" panose="02020500000000000000" pitchFamily="18" charset="-120"/>
              </a:rPr>
              <a:t> </a:t>
            </a:r>
            <a:r>
              <a:rPr lang="en-US" altLang="zh-TW" sz="1200" kern="0" dirty="0">
                <a:solidFill>
                  <a:srgbClr val="000000"/>
                </a:solidFill>
                <a:ea typeface="新細明體" panose="02020500000000000000" pitchFamily="18" charset="-120"/>
              </a:rPr>
              <a:t>The SEIR and SEIQR curves before and after the Agent’s engagement for the first 4 epidemic waves.</a:t>
            </a:r>
            <a:endParaRPr lang="zh-TW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105703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3</Words>
  <Application>Microsoft Office PowerPoint</Application>
  <PresentationFormat>自訂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ien-Chang Chen</dc:creator>
  <cp:lastModifiedBy>Chien-Chang Chen</cp:lastModifiedBy>
  <cp:revision>3</cp:revision>
  <dcterms:created xsi:type="dcterms:W3CDTF">2024-02-17T00:11:06Z</dcterms:created>
  <dcterms:modified xsi:type="dcterms:W3CDTF">2024-02-19T02:18:41Z</dcterms:modified>
</cp:coreProperties>
</file>